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1D7DE-000C-4978-814D-41D305EF9D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A3CE6-71B8-4455-B52A-7E8EA5C2E7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1C57B-39F5-4BD7-BEF3-B29B1C3295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A4AC9-68F2-4791-AA92-D88F01AB0A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6C734-EA7A-408A-A14D-792ABAC371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EDBFA-5947-4833-B8EC-2E7782DA05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908703-132E-412C-BED4-F9704529BB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4549A-26AF-4BA1-B657-0DFC0450C8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5B5FE-C3D8-49F8-BC31-DB81643DDA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41C48-B541-4F7A-B6FE-246A377CB5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EBD55-ED84-4503-9D6B-646FF380F5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25191-75DB-4DA1-A92E-80ACB320C5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88C86C-AAF7-470B-9820-65D3A83AE6B2}" type="slidenum">
              <a:rPr b="0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1080" y="907920"/>
            <a:ext cx="91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P- ERK1/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3440" y="1413000"/>
            <a:ext cx="73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66880" y="453960"/>
            <a:ext cx="344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C      15’         30’          C         15’      30’     I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3348000" y="404280"/>
            <a:ext cx="1439640" cy="216000"/>
            <a:chOff x="3348000" y="404280"/>
            <a:chExt cx="1439640" cy="216000"/>
          </a:xfrm>
        </p:grpSpPr>
        <p:sp>
          <p:nvSpPr>
            <p:cNvPr id="45" name=""/>
            <p:cNvSpPr/>
            <p:nvPr/>
          </p:nvSpPr>
          <p:spPr>
            <a:xfrm flipV="1">
              <a:off x="3348000" y="40428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348000" y="404640"/>
              <a:ext cx="143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787640" y="40464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3781080" y="115920"/>
            <a:ext cx="72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+U012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rcRect l="1957" t="4569" r="2663" b="14323"/>
          <a:stretch/>
        </p:blipFill>
        <p:spPr>
          <a:xfrm>
            <a:off x="1542960" y="1501920"/>
            <a:ext cx="3246480" cy="19836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2"/>
          <a:srcRect l="484" t="13097" r="7938" b="5422"/>
          <a:stretch/>
        </p:blipFill>
        <p:spPr>
          <a:xfrm>
            <a:off x="1547640" y="836640"/>
            <a:ext cx="3313440" cy="4539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1116000" y="1052640"/>
            <a:ext cx="2890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116000" y="1555920"/>
            <a:ext cx="2890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47640" y="836640"/>
            <a:ext cx="3249720" cy="45576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547640" y="1484280"/>
            <a:ext cx="3241800" cy="216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26920" y="2972520"/>
            <a:ext cx="6481800" cy="91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2. Activation of ERK by IL-1β in HepG2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epG2 cells were stimulated by IL-1β (15ng/ml) for 15 and 30 min and the phosphorylation of ERK1/2 was analyzed by western blot analysis. To some experimental groups U0126 (10μM) was added 30 min prior IL-1β stimulation (lanes 4-6)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2T12:06:12Z</dcterms:created>
  <dc:creator>x</dc:creator>
  <dc:description/>
  <dc:language>en-US</dc:language>
  <cp:lastModifiedBy>Kate Mosford</cp:lastModifiedBy>
  <dcterms:modified xsi:type="dcterms:W3CDTF">2010-01-21T16:02:24Z</dcterms:modified>
  <cp:revision>41</cp:revision>
  <dc:subject/>
  <dc:title>Slajd 1</dc:title>
</cp:coreProperties>
</file>